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8" r:id="rId2"/>
    <p:sldId id="261" r:id="rId3"/>
    <p:sldId id="256" r:id="rId4"/>
    <p:sldId id="262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5106"/>
  </p:normalViewPr>
  <p:slideViewPr>
    <p:cSldViewPr snapToGrid="0" snapToObjects="1">
      <p:cViewPr varScale="1">
        <p:scale>
          <a:sx n="96" d="100"/>
          <a:sy n="96" d="100"/>
        </p:scale>
        <p:origin x="11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3:$L$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3493894014425352</c:v>
                  </c:pt>
                  <c:pt idx="2">
                    <c:v>0.10386366774159077</c:v>
                  </c:pt>
                  <c:pt idx="3">
                    <c:v>1.9330577545550105</c:v>
                  </c:pt>
                  <c:pt idx="4">
                    <c:v>1.3647814474022801</c:v>
                  </c:pt>
                  <c:pt idx="5">
                    <c:v>0.33485376226213032</c:v>
                  </c:pt>
                </c:numCache>
              </c:numRef>
            </c:plus>
            <c:minus>
              <c:numRef>
                <c:f>Sheet1!$L$3:$L$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3493894014425352</c:v>
                  </c:pt>
                  <c:pt idx="2">
                    <c:v>0.10386366774159077</c:v>
                  </c:pt>
                  <c:pt idx="3">
                    <c:v>1.9330577545550105</c:v>
                  </c:pt>
                  <c:pt idx="4">
                    <c:v>1.3647814474022801</c:v>
                  </c:pt>
                  <c:pt idx="5">
                    <c:v>0.334853762262130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3:$I$8</c:f>
              <c:strCache>
                <c:ptCount val="6"/>
                <c:pt idx="0">
                  <c:v>SF control</c:v>
                </c:pt>
                <c:pt idx="1">
                  <c:v>VEGF-A165a</c:v>
                </c:pt>
                <c:pt idx="2">
                  <c:v>VEGF-A165b</c:v>
                </c:pt>
                <c:pt idx="3">
                  <c:v>DMSO</c:v>
                </c:pt>
                <c:pt idx="4">
                  <c:v>ESSO 1</c:v>
                </c:pt>
                <c:pt idx="5">
                  <c:v>ESSO 3</c:v>
                </c:pt>
              </c:strCache>
            </c:strRef>
          </c:cat>
          <c:val>
            <c:numRef>
              <c:f>Sheet1!$J$3:$J$8</c:f>
              <c:numCache>
                <c:formatCode>General</c:formatCode>
                <c:ptCount val="6"/>
                <c:pt idx="0">
                  <c:v>1</c:v>
                </c:pt>
                <c:pt idx="1">
                  <c:v>1.8291648383794059</c:v>
                </c:pt>
                <c:pt idx="2">
                  <c:v>1.2257946423582122</c:v>
                </c:pt>
                <c:pt idx="3">
                  <c:v>5.1823901184901464</c:v>
                </c:pt>
                <c:pt idx="4">
                  <c:v>2.444712574635298</c:v>
                </c:pt>
                <c:pt idx="5">
                  <c:v>0.67556708429485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27-9A46-9B9E-202D46F28A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66682080"/>
        <c:axId val="1066683248"/>
      </c:barChart>
      <c:catAx>
        <c:axId val="1066682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6683248"/>
        <c:crosses val="autoZero"/>
        <c:auto val="1"/>
        <c:lblAlgn val="ctr"/>
        <c:lblOffset val="100"/>
        <c:noMultiLvlLbl val="0"/>
      </c:catAx>
      <c:valAx>
        <c:axId val="10666832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6682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534B20-8DDB-7B4C-8F4A-9E80C07A4908}" type="datetimeFigureOut">
              <a:rPr lang="en-US" smtClean="0"/>
              <a:t>4/8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AB041F-C297-4148-9333-835CC43BA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02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dirty="0">
                <a:latin typeface="Symbol" pitchFamily="2" charset="2"/>
              </a:rPr>
              <a:t>1 and 2 </a:t>
            </a:r>
            <a:r>
              <a:rPr lang="en-US" dirty="0" err="1">
                <a:latin typeface="Symbol" pitchFamily="2" charset="2"/>
              </a:rPr>
              <a:t>hr</a:t>
            </a:r>
            <a:r>
              <a:rPr lang="en-US" dirty="0">
                <a:latin typeface="Symbol" pitchFamily="2" charset="2"/>
              </a:rPr>
              <a:t> splicing timepoints of WT VEGF-A splicing reporter and </a:t>
            </a:r>
            <a:r>
              <a:rPr lang="en-US" dirty="0" err="1">
                <a:latin typeface="Symbol" pitchFamily="2" charset="2"/>
              </a:rPr>
              <a:t>Delta</a:t>
            </a:r>
            <a:r>
              <a:rPr lang="en-US" dirty="0" err="1"/>
              <a:t>BP</a:t>
            </a:r>
            <a:r>
              <a:rPr lang="en-US" dirty="0"/>
              <a:t>  with mutations in the branch point at -30 and -31 from exon 8a (CCCTAAC to </a:t>
            </a:r>
            <a:r>
              <a:rPr lang="en-US" dirty="0" err="1"/>
              <a:t>CCCTggC</a:t>
            </a:r>
            <a:r>
              <a:rPr lang="en-US" dirty="0"/>
              <a:t>)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dirty="0"/>
              <a:t>2 </a:t>
            </a:r>
            <a:r>
              <a:rPr lang="en-US" dirty="0" err="1"/>
              <a:t>hr</a:t>
            </a:r>
            <a:r>
              <a:rPr lang="en-US" dirty="0"/>
              <a:t> splicing reactions showing titrations (0, 1, 5, 10 </a:t>
            </a:r>
            <a:r>
              <a:rPr lang="en-US" dirty="0" err="1"/>
              <a:t>uM</a:t>
            </a:r>
            <a:r>
              <a:rPr lang="en-US" dirty="0"/>
              <a:t>) of ESSOs 2-8.  Size markers on the left of panel A WT and panel B ESSO8 are </a:t>
            </a:r>
            <a:r>
              <a:rPr lang="en-US" dirty="0" err="1"/>
              <a:t>PhiX</a:t>
            </a:r>
            <a:r>
              <a:rPr lang="en-US" dirty="0"/>
              <a:t> </a:t>
            </a:r>
            <a:r>
              <a:rPr lang="en-US" dirty="0" err="1"/>
              <a:t>HaeIII</a:t>
            </a:r>
            <a:r>
              <a:rPr lang="en-US" dirty="0"/>
              <a:t> DNA markers (1353, 1078, 872, 603, 310, 281, 271, 234,194 </a:t>
            </a:r>
            <a:r>
              <a:rPr lang="en-US" dirty="0" err="1"/>
              <a:t>nt</a:t>
            </a:r>
            <a:r>
              <a:rPr lang="en-US" dirty="0"/>
              <a:t>).  Polyacrylamide gels were 5 or 6%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AB041F-C297-4148-9333-835CC43BA48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9491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AB041F-C297-4148-9333-835CC43BA48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1506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374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702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920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295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34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630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685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09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780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14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16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05FD2-06F2-CC4B-BCBB-B9C82D1A9B7F}" type="datetimeFigureOut">
              <a:rPr lang="en-US" smtClean="0"/>
              <a:t>4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2914E8-8AFC-874F-9CD6-2139100F09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986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12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125682" y="4473394"/>
            <a:ext cx="78483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Arial" charset="0"/>
                <a:ea typeface="Arial" charset="0"/>
                <a:cs typeface="Arial" charset="0"/>
              </a:rPr>
              <a:t>Supplementary Figure 1</a:t>
            </a:r>
            <a:r>
              <a:rPr lang="en-GB" sz="1400" dirty="0">
                <a:latin typeface="Arial" charset="0"/>
                <a:ea typeface="Arial" charset="0"/>
                <a:cs typeface="Arial" charset="0"/>
              </a:rPr>
              <a:t>.  Natural extract DIAVIT reduces the ratio of VEGF reporter splice site selection when HEK293 cells stably transfected with the VEGF reporter were cultured with three increasing doses of a DIAVIT solution for 48 hours. n=3, **P&lt;0.01 vs. untreated dsRED/EGFP. </a:t>
            </a:r>
            <a:r>
              <a:rPr lang="en-GB" sz="1400" baseline="30000" dirty="0">
                <a:latin typeface="Arial" charset="0"/>
                <a:ea typeface="Arial" charset="0"/>
                <a:cs typeface="Arial" charset="0"/>
              </a:rPr>
              <a:t>#</a:t>
            </a:r>
            <a:r>
              <a:rPr lang="en-GB" sz="1400" dirty="0">
                <a:latin typeface="Arial" charset="0"/>
                <a:ea typeface="Arial" charset="0"/>
                <a:cs typeface="Arial" charset="0"/>
              </a:rPr>
              <a:t>P&lt;0.01 vs. untreated </a:t>
            </a:r>
            <a:r>
              <a:rPr lang="en-GB" sz="1400" dirty="0" err="1">
                <a:latin typeface="Arial" charset="0"/>
                <a:ea typeface="Arial" charset="0"/>
                <a:cs typeface="Arial" charset="0"/>
              </a:rPr>
              <a:t>dsRED+EGFP</a:t>
            </a:r>
            <a:r>
              <a:rPr lang="en-GB" sz="1400" dirty="0">
                <a:latin typeface="Arial" charset="0"/>
                <a:ea typeface="Arial" charset="0"/>
                <a:cs typeface="Arial" charset="0"/>
              </a:rPr>
              <a:t>. The values on X and Y axis are arbitrary and are proportional to </a:t>
            </a:r>
            <a:r>
              <a:rPr lang="en-GB" sz="1400" dirty="0" err="1">
                <a:latin typeface="Arial" charset="0"/>
                <a:ea typeface="Arial" charset="0"/>
                <a:cs typeface="Arial" charset="0"/>
              </a:rPr>
              <a:t>dsRED</a:t>
            </a:r>
            <a:r>
              <a:rPr lang="en-GB" sz="1400" dirty="0">
                <a:latin typeface="Arial" charset="0"/>
                <a:ea typeface="Arial" charset="0"/>
                <a:cs typeface="Arial" charset="0"/>
              </a:rPr>
              <a:t> and EGFP fluorescence intensities as measured on the plate reader.</a:t>
            </a: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E1A32F26-6F36-0446-953E-B3A240C16A35}"/>
              </a:ext>
            </a:extLst>
          </p:cNvPr>
          <p:cNvGrpSpPr/>
          <p:nvPr/>
        </p:nvGrpSpPr>
        <p:grpSpPr>
          <a:xfrm>
            <a:off x="2269995" y="417487"/>
            <a:ext cx="5458460" cy="3771900"/>
            <a:chOff x="2269995" y="417487"/>
            <a:chExt cx="5458460" cy="3771900"/>
          </a:xfrm>
        </p:grpSpPr>
        <p:pic>
          <p:nvPicPr>
            <p:cNvPr id="2" name="Picture 1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9995" y="417487"/>
              <a:ext cx="5458460" cy="37719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98AC957-0EA0-F748-B8AE-0258A34D954A}"/>
                </a:ext>
              </a:extLst>
            </p:cNvPr>
            <p:cNvSpPr txBox="1"/>
            <p:nvPr/>
          </p:nvSpPr>
          <p:spPr>
            <a:xfrm>
              <a:off x="5800651" y="1392569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CA5A48E-DC29-8448-9505-B65A24DC2378}"/>
                </a:ext>
              </a:extLst>
            </p:cNvPr>
            <p:cNvSpPr txBox="1"/>
            <p:nvPr/>
          </p:nvSpPr>
          <p:spPr>
            <a:xfrm>
              <a:off x="5873587" y="1957837"/>
              <a:ext cx="2696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aseline="30000" dirty="0">
                  <a:latin typeface="Arial" charset="0"/>
                  <a:ea typeface="Arial" charset="0"/>
                  <a:cs typeface="Arial" charset="0"/>
                </a:rPr>
                <a:t>#</a:t>
              </a:r>
              <a:endParaRPr lang="en-US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EFA2DB8-1474-3043-B12D-7B1C1DFFF876}"/>
                </a:ext>
              </a:extLst>
            </p:cNvPr>
            <p:cNvSpPr txBox="1"/>
            <p:nvPr/>
          </p:nvSpPr>
          <p:spPr>
            <a:xfrm>
              <a:off x="6394955" y="1957837"/>
              <a:ext cx="1333500" cy="20116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98952AF-2B5F-D740-AA3E-0ED700356BD2}"/>
                </a:ext>
              </a:extLst>
            </p:cNvPr>
            <p:cNvSpPr txBox="1"/>
            <p:nvPr/>
          </p:nvSpPr>
          <p:spPr>
            <a:xfrm>
              <a:off x="5549399" y="2973030"/>
              <a:ext cx="1333500" cy="20116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016808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9F9B0CF-9BDC-E34B-8AFF-EC2F76C1183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897" t="3372" r="1574" b="15556"/>
          <a:stretch/>
        </p:blipFill>
        <p:spPr>
          <a:xfrm>
            <a:off x="677041" y="733119"/>
            <a:ext cx="864953" cy="55599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ABBBFF0-A09E-DD4E-AB3F-AA5DC35CD9D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90" t="4291" r="-1272" b="14636"/>
          <a:stretch/>
        </p:blipFill>
        <p:spPr>
          <a:xfrm>
            <a:off x="1759607" y="733119"/>
            <a:ext cx="567558" cy="55599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9B876AD-75D1-F343-9F16-A148D16D3AF8}"/>
              </a:ext>
            </a:extLst>
          </p:cNvPr>
          <p:cNvSpPr txBox="1"/>
          <p:nvPr/>
        </p:nvSpPr>
        <p:spPr>
          <a:xfrm>
            <a:off x="1021734" y="3637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1415736-C2D4-0C49-BE59-27A2CE06EA34}"/>
              </a:ext>
            </a:extLst>
          </p:cNvPr>
          <p:cNvSpPr txBox="1"/>
          <p:nvPr/>
        </p:nvSpPr>
        <p:spPr>
          <a:xfrm>
            <a:off x="1260360" y="3637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2636852-C9C5-5C4A-8B89-15BD8C5FF892}"/>
              </a:ext>
            </a:extLst>
          </p:cNvPr>
          <p:cNvSpPr txBox="1"/>
          <p:nvPr/>
        </p:nvSpPr>
        <p:spPr>
          <a:xfrm>
            <a:off x="1759444" y="3637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252B3B-1A1C-0648-9BB8-C5F9FC111598}"/>
              </a:ext>
            </a:extLst>
          </p:cNvPr>
          <p:cNvSpPr txBox="1"/>
          <p:nvPr/>
        </p:nvSpPr>
        <p:spPr>
          <a:xfrm>
            <a:off x="1998070" y="3637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2833FA-EC2B-6C4C-B1C4-27C635E1AB89}"/>
              </a:ext>
            </a:extLst>
          </p:cNvPr>
          <p:cNvSpPr txBox="1"/>
          <p:nvPr/>
        </p:nvSpPr>
        <p:spPr>
          <a:xfrm>
            <a:off x="973280" y="-8069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9BD604-AEE9-A748-B316-8309FD604889}"/>
              </a:ext>
            </a:extLst>
          </p:cNvPr>
          <p:cNvSpPr txBox="1"/>
          <p:nvPr/>
        </p:nvSpPr>
        <p:spPr>
          <a:xfrm>
            <a:off x="1597781" y="-80697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D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245277-C5B9-D74F-B4F9-859AD2186786}"/>
              </a:ext>
            </a:extLst>
          </p:cNvPr>
          <p:cNvSpPr txBox="1"/>
          <p:nvPr/>
        </p:nvSpPr>
        <p:spPr>
          <a:xfrm>
            <a:off x="127000" y="-12478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F5513F-7CF5-B94E-A49C-A32DC9A63D11}"/>
              </a:ext>
            </a:extLst>
          </p:cNvPr>
          <p:cNvSpPr txBox="1"/>
          <p:nvPr/>
        </p:nvSpPr>
        <p:spPr>
          <a:xfrm>
            <a:off x="0" y="363787"/>
            <a:ext cx="1112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5C82B7-0820-E349-8DE1-026DE8631916}"/>
              </a:ext>
            </a:extLst>
          </p:cNvPr>
          <p:cNvSpPr txBox="1"/>
          <p:nvPr/>
        </p:nvSpPr>
        <p:spPr>
          <a:xfrm>
            <a:off x="2667000" y="-12478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5EF5801E-F471-D94C-B7B9-79AD86ADCAB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093" r="1801"/>
          <a:stretch/>
        </p:blipFill>
        <p:spPr>
          <a:xfrm>
            <a:off x="3149148" y="729926"/>
            <a:ext cx="803525" cy="50029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35BA067-44B1-BB46-9976-1D846CEAD31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396" b="12103"/>
          <a:stretch/>
        </p:blipFill>
        <p:spPr>
          <a:xfrm>
            <a:off x="6453474" y="729926"/>
            <a:ext cx="780171" cy="47331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A07EEED-9542-2A45-93FD-4B65608AC48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5385" r="-1147" b="2315"/>
          <a:stretch/>
        </p:blipFill>
        <p:spPr>
          <a:xfrm>
            <a:off x="7419472" y="729926"/>
            <a:ext cx="785796" cy="49702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9D65D87-8396-6A47-819C-618A1DE4EBB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6021" r="-920" b="1681"/>
          <a:stretch/>
        </p:blipFill>
        <p:spPr>
          <a:xfrm>
            <a:off x="5224108" y="729926"/>
            <a:ext cx="1043539" cy="49702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5E333AB-7F72-1744-906A-5DD0108B217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-3235" b="7093"/>
          <a:stretch/>
        </p:blipFill>
        <p:spPr>
          <a:xfrm>
            <a:off x="4192507" y="729926"/>
            <a:ext cx="845774" cy="50029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706FACB-E0AA-7245-9681-C4CAB80C9B3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" t="11865" r="665"/>
          <a:stretch/>
        </p:blipFill>
        <p:spPr>
          <a:xfrm>
            <a:off x="8391096" y="729926"/>
            <a:ext cx="1043539" cy="47459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Right Triangle 19">
            <a:extLst>
              <a:ext uri="{FF2B5EF4-FFF2-40B4-BE49-F238E27FC236}">
                <a16:creationId xmlns:a16="http://schemas.microsoft.com/office/drawing/2014/main" id="{9622EE09-5C31-614B-BD51-FA1649900922}"/>
              </a:ext>
            </a:extLst>
          </p:cNvPr>
          <p:cNvSpPr/>
          <p:nvPr/>
        </p:nvSpPr>
        <p:spPr>
          <a:xfrm flipH="1">
            <a:off x="8896844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Triangle 22">
            <a:extLst>
              <a:ext uri="{FF2B5EF4-FFF2-40B4-BE49-F238E27FC236}">
                <a16:creationId xmlns:a16="http://schemas.microsoft.com/office/drawing/2014/main" id="{586A882A-9F5C-3747-B40A-522479808388}"/>
              </a:ext>
            </a:extLst>
          </p:cNvPr>
          <p:cNvSpPr/>
          <p:nvPr/>
        </p:nvSpPr>
        <p:spPr>
          <a:xfrm flipH="1">
            <a:off x="7690344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Triangle 23">
            <a:extLst>
              <a:ext uri="{FF2B5EF4-FFF2-40B4-BE49-F238E27FC236}">
                <a16:creationId xmlns:a16="http://schemas.microsoft.com/office/drawing/2014/main" id="{0F8C54D4-69FF-5340-87AC-286A11379039}"/>
              </a:ext>
            </a:extLst>
          </p:cNvPr>
          <p:cNvSpPr/>
          <p:nvPr/>
        </p:nvSpPr>
        <p:spPr>
          <a:xfrm flipH="1">
            <a:off x="6699744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ight Triangle 24">
            <a:extLst>
              <a:ext uri="{FF2B5EF4-FFF2-40B4-BE49-F238E27FC236}">
                <a16:creationId xmlns:a16="http://schemas.microsoft.com/office/drawing/2014/main" id="{C14F5EEB-1F13-4145-BF1A-7E702DBC07C8}"/>
              </a:ext>
            </a:extLst>
          </p:cNvPr>
          <p:cNvSpPr/>
          <p:nvPr/>
        </p:nvSpPr>
        <p:spPr>
          <a:xfrm flipH="1">
            <a:off x="5747244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ight Triangle 25">
            <a:extLst>
              <a:ext uri="{FF2B5EF4-FFF2-40B4-BE49-F238E27FC236}">
                <a16:creationId xmlns:a16="http://schemas.microsoft.com/office/drawing/2014/main" id="{6703D07E-5BA6-B147-9E45-A628153B2F1A}"/>
              </a:ext>
            </a:extLst>
          </p:cNvPr>
          <p:cNvSpPr/>
          <p:nvPr/>
        </p:nvSpPr>
        <p:spPr>
          <a:xfrm flipH="1">
            <a:off x="4502644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ight Triangle 27">
            <a:extLst>
              <a:ext uri="{FF2B5EF4-FFF2-40B4-BE49-F238E27FC236}">
                <a16:creationId xmlns:a16="http://schemas.microsoft.com/office/drawing/2014/main" id="{F1642F42-D3F7-9E47-B074-EDCC87875CD9}"/>
              </a:ext>
            </a:extLst>
          </p:cNvPr>
          <p:cNvSpPr/>
          <p:nvPr/>
        </p:nvSpPr>
        <p:spPr>
          <a:xfrm flipH="1">
            <a:off x="3428999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76E6D7F-86E5-1440-8022-CD4757EFD84B}"/>
              </a:ext>
            </a:extLst>
          </p:cNvPr>
          <p:cNvSpPr txBox="1"/>
          <p:nvPr/>
        </p:nvSpPr>
        <p:spPr>
          <a:xfrm>
            <a:off x="3201857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84E6DED-364D-BE47-BAD9-614DF405FE11}"/>
              </a:ext>
            </a:extLst>
          </p:cNvPr>
          <p:cNvSpPr txBox="1"/>
          <p:nvPr/>
        </p:nvSpPr>
        <p:spPr>
          <a:xfrm>
            <a:off x="4326302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E5DD0B9-60DF-974B-800E-8FC04A355726}"/>
              </a:ext>
            </a:extLst>
          </p:cNvPr>
          <p:cNvSpPr txBox="1"/>
          <p:nvPr/>
        </p:nvSpPr>
        <p:spPr>
          <a:xfrm>
            <a:off x="5482002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C576DAC-A234-6541-B4FE-90B7433F7F7E}"/>
              </a:ext>
            </a:extLst>
          </p:cNvPr>
          <p:cNvSpPr txBox="1"/>
          <p:nvPr/>
        </p:nvSpPr>
        <p:spPr>
          <a:xfrm>
            <a:off x="6498002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9A5267E-6421-3C49-B9A1-587839BA6AC3}"/>
              </a:ext>
            </a:extLst>
          </p:cNvPr>
          <p:cNvSpPr txBox="1"/>
          <p:nvPr/>
        </p:nvSpPr>
        <p:spPr>
          <a:xfrm>
            <a:off x="7514002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342AC7F-C18C-2444-AE67-0C3882C7CCFF}"/>
              </a:ext>
            </a:extLst>
          </p:cNvPr>
          <p:cNvSpPr txBox="1"/>
          <p:nvPr/>
        </p:nvSpPr>
        <p:spPr>
          <a:xfrm>
            <a:off x="8644302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8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113D55A1-062B-F044-9034-7668FC82478B}"/>
              </a:ext>
            </a:extLst>
          </p:cNvPr>
          <p:cNvGrpSpPr/>
          <p:nvPr/>
        </p:nvGrpSpPr>
        <p:grpSpPr>
          <a:xfrm>
            <a:off x="10547777" y="1552566"/>
            <a:ext cx="1444668" cy="187890"/>
            <a:chOff x="10597328" y="2507226"/>
            <a:chExt cx="1444668" cy="187890"/>
          </a:xfrm>
        </p:grpSpPr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84DE377-E28D-FA4B-9E28-20F138E366D4}"/>
                </a:ext>
              </a:extLst>
            </p:cNvPr>
            <p:cNvSpPr/>
            <p:nvPr/>
          </p:nvSpPr>
          <p:spPr>
            <a:xfrm>
              <a:off x="10597328" y="2507226"/>
              <a:ext cx="275572" cy="1878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E49E8B06-D608-224B-8426-244488007872}"/>
                </a:ext>
              </a:extLst>
            </p:cNvPr>
            <p:cNvSpPr/>
            <p:nvPr/>
          </p:nvSpPr>
          <p:spPr>
            <a:xfrm>
              <a:off x="11626550" y="2507226"/>
              <a:ext cx="144000" cy="1878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4C43B07B-0AEB-DD48-B7C3-B573F7AABF6B}"/>
                </a:ext>
              </a:extLst>
            </p:cNvPr>
            <p:cNvSpPr/>
            <p:nvPr/>
          </p:nvSpPr>
          <p:spPr>
            <a:xfrm>
              <a:off x="11766424" y="2507226"/>
              <a:ext cx="275572" cy="187890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4D0BF536-E99B-8448-8868-BE98A7BEE6F7}"/>
                </a:ext>
              </a:extLst>
            </p:cNvPr>
            <p:cNvCxnSpPr>
              <a:stCxn id="37" idx="3"/>
              <a:endCxn id="38" idx="1"/>
            </p:cNvCxnSpPr>
            <p:nvPr/>
          </p:nvCxnSpPr>
          <p:spPr>
            <a:xfrm>
              <a:off x="10872900" y="2601171"/>
              <a:ext cx="7536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1315D9A2-7E08-DD48-B7C7-4CC4CAE51322}"/>
              </a:ext>
            </a:extLst>
          </p:cNvPr>
          <p:cNvGrpSpPr/>
          <p:nvPr/>
        </p:nvGrpSpPr>
        <p:grpSpPr>
          <a:xfrm>
            <a:off x="10555922" y="2776823"/>
            <a:ext cx="686843" cy="187890"/>
            <a:chOff x="10530522" y="4281747"/>
            <a:chExt cx="686843" cy="187890"/>
          </a:xfrm>
        </p:grpSpPr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50BBA1B4-A462-274C-8681-5C67CE111FE9}"/>
                </a:ext>
              </a:extLst>
            </p:cNvPr>
            <p:cNvSpPr/>
            <p:nvPr/>
          </p:nvSpPr>
          <p:spPr>
            <a:xfrm>
              <a:off x="10530522" y="4281747"/>
              <a:ext cx="275572" cy="1878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1862FBC-D85F-3742-87E1-2586CB9FA06E}"/>
                </a:ext>
              </a:extLst>
            </p:cNvPr>
            <p:cNvSpPr/>
            <p:nvPr/>
          </p:nvSpPr>
          <p:spPr>
            <a:xfrm>
              <a:off x="10801919" y="4281747"/>
              <a:ext cx="144000" cy="1878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A47404AF-3DBD-1646-BA7F-D6E7F30AE15D}"/>
                </a:ext>
              </a:extLst>
            </p:cNvPr>
            <p:cNvSpPr/>
            <p:nvPr/>
          </p:nvSpPr>
          <p:spPr>
            <a:xfrm>
              <a:off x="10941793" y="4281747"/>
              <a:ext cx="275572" cy="187890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CF54CE3E-7F8E-054F-8530-D00B5AD23F49}"/>
              </a:ext>
            </a:extLst>
          </p:cNvPr>
          <p:cNvGrpSpPr/>
          <p:nvPr/>
        </p:nvGrpSpPr>
        <p:grpSpPr>
          <a:xfrm>
            <a:off x="10568408" y="1175566"/>
            <a:ext cx="557311" cy="243356"/>
            <a:chOff x="7795462" y="1215927"/>
            <a:chExt cx="557311" cy="243356"/>
          </a:xfrm>
        </p:grpSpPr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8EFA5C1C-BAEA-5F43-ADA7-09B81186D046}"/>
                </a:ext>
              </a:extLst>
            </p:cNvPr>
            <p:cNvCxnSpPr>
              <a:cxnSpLocks/>
            </p:cNvCxnSpPr>
            <p:nvPr/>
          </p:nvCxnSpPr>
          <p:spPr>
            <a:xfrm>
              <a:off x="7922712" y="1459283"/>
              <a:ext cx="43006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93DAAEEA-C243-4541-B477-A57E37E2049E}"/>
                </a:ext>
              </a:extLst>
            </p:cNvPr>
            <p:cNvSpPr/>
            <p:nvPr/>
          </p:nvSpPr>
          <p:spPr>
            <a:xfrm>
              <a:off x="7795462" y="1215927"/>
              <a:ext cx="427875" cy="243355"/>
            </a:xfrm>
            <a:custGeom>
              <a:avLst/>
              <a:gdLst>
                <a:gd name="connsiteX0" fmla="*/ 127250 w 427875"/>
                <a:gd name="connsiteY0" fmla="*/ 243355 h 243355"/>
                <a:gd name="connsiteX1" fmla="*/ 1990 w 427875"/>
                <a:gd name="connsiteY1" fmla="*/ 186988 h 243355"/>
                <a:gd name="connsiteX2" fmla="*/ 70883 w 427875"/>
                <a:gd name="connsiteY2" fmla="*/ 17887 h 243355"/>
                <a:gd name="connsiteX3" fmla="*/ 327667 w 427875"/>
                <a:gd name="connsiteY3" fmla="*/ 30413 h 243355"/>
                <a:gd name="connsiteX4" fmla="*/ 427875 w 427875"/>
                <a:gd name="connsiteY4" fmla="*/ 243355 h 2433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27875" h="243355">
                  <a:moveTo>
                    <a:pt x="127250" y="243355"/>
                  </a:moveTo>
                  <a:cubicBezTo>
                    <a:pt x="69317" y="233960"/>
                    <a:pt x="11385" y="224566"/>
                    <a:pt x="1990" y="186988"/>
                  </a:cubicBezTo>
                  <a:cubicBezTo>
                    <a:pt x="-7405" y="149410"/>
                    <a:pt x="16604" y="43983"/>
                    <a:pt x="70883" y="17887"/>
                  </a:cubicBezTo>
                  <a:cubicBezTo>
                    <a:pt x="125162" y="-8209"/>
                    <a:pt x="268168" y="-7165"/>
                    <a:pt x="327667" y="30413"/>
                  </a:cubicBezTo>
                  <a:cubicBezTo>
                    <a:pt x="387166" y="67991"/>
                    <a:pt x="407520" y="155673"/>
                    <a:pt x="427875" y="243355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593BDB49-00F7-F04D-9567-196E0BC958C8}"/>
              </a:ext>
            </a:extLst>
          </p:cNvPr>
          <p:cNvGrpSpPr/>
          <p:nvPr/>
        </p:nvGrpSpPr>
        <p:grpSpPr>
          <a:xfrm>
            <a:off x="10572755" y="824225"/>
            <a:ext cx="981108" cy="345653"/>
            <a:chOff x="10712247" y="1543622"/>
            <a:chExt cx="981108" cy="345653"/>
          </a:xfrm>
        </p:grpSpPr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41B973AB-90D9-F24F-8EE5-40751C28F34D}"/>
                </a:ext>
              </a:extLst>
            </p:cNvPr>
            <p:cNvSpPr/>
            <p:nvPr/>
          </p:nvSpPr>
          <p:spPr>
            <a:xfrm>
              <a:off x="11277909" y="1701385"/>
              <a:ext cx="144000" cy="1878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6590DDEE-080F-D242-9624-C74DD02664DA}"/>
                </a:ext>
              </a:extLst>
            </p:cNvPr>
            <p:cNvSpPr/>
            <p:nvPr/>
          </p:nvSpPr>
          <p:spPr>
            <a:xfrm>
              <a:off x="11417783" y="1701385"/>
              <a:ext cx="275572" cy="187890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50C4D98E-E8FE-0949-AAE2-ABF5CF0B6AA3}"/>
                </a:ext>
              </a:extLst>
            </p:cNvPr>
            <p:cNvGrpSpPr/>
            <p:nvPr/>
          </p:nvGrpSpPr>
          <p:grpSpPr>
            <a:xfrm>
              <a:off x="10712247" y="1543622"/>
              <a:ext cx="557311" cy="243356"/>
              <a:chOff x="7795462" y="1215927"/>
              <a:chExt cx="557311" cy="243356"/>
            </a:xfrm>
          </p:grpSpPr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332C428A-D743-DE42-93D1-32F6D92D00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22712" y="1459283"/>
                <a:ext cx="43006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Freeform 52">
                <a:extLst>
                  <a:ext uri="{FF2B5EF4-FFF2-40B4-BE49-F238E27FC236}">
                    <a16:creationId xmlns:a16="http://schemas.microsoft.com/office/drawing/2014/main" id="{C1458107-C070-D540-BDBA-384BB3DA281C}"/>
                  </a:ext>
                </a:extLst>
              </p:cNvPr>
              <p:cNvSpPr/>
              <p:nvPr/>
            </p:nvSpPr>
            <p:spPr>
              <a:xfrm>
                <a:off x="7795462" y="1215927"/>
                <a:ext cx="427875" cy="243355"/>
              </a:xfrm>
              <a:custGeom>
                <a:avLst/>
                <a:gdLst>
                  <a:gd name="connsiteX0" fmla="*/ 127250 w 427875"/>
                  <a:gd name="connsiteY0" fmla="*/ 243355 h 243355"/>
                  <a:gd name="connsiteX1" fmla="*/ 1990 w 427875"/>
                  <a:gd name="connsiteY1" fmla="*/ 186988 h 243355"/>
                  <a:gd name="connsiteX2" fmla="*/ 70883 w 427875"/>
                  <a:gd name="connsiteY2" fmla="*/ 17887 h 243355"/>
                  <a:gd name="connsiteX3" fmla="*/ 327667 w 427875"/>
                  <a:gd name="connsiteY3" fmla="*/ 30413 h 243355"/>
                  <a:gd name="connsiteX4" fmla="*/ 427875 w 427875"/>
                  <a:gd name="connsiteY4" fmla="*/ 243355 h 2433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27875" h="243355">
                    <a:moveTo>
                      <a:pt x="127250" y="243355"/>
                    </a:moveTo>
                    <a:cubicBezTo>
                      <a:pt x="69317" y="233960"/>
                      <a:pt x="11385" y="224566"/>
                      <a:pt x="1990" y="186988"/>
                    </a:cubicBezTo>
                    <a:cubicBezTo>
                      <a:pt x="-7405" y="149410"/>
                      <a:pt x="16604" y="43983"/>
                      <a:pt x="70883" y="17887"/>
                    </a:cubicBezTo>
                    <a:cubicBezTo>
                      <a:pt x="125162" y="-8209"/>
                      <a:pt x="268168" y="-7165"/>
                      <a:pt x="327667" y="30413"/>
                    </a:cubicBezTo>
                    <a:cubicBezTo>
                      <a:pt x="387166" y="67991"/>
                      <a:pt x="407520" y="155673"/>
                      <a:pt x="427875" y="243355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1" name="Rectangle 20">
            <a:extLst>
              <a:ext uri="{FF2B5EF4-FFF2-40B4-BE49-F238E27FC236}">
                <a16:creationId xmlns:a16="http://schemas.microsoft.com/office/drawing/2014/main" id="{3B7720FB-F97E-124B-B75A-93C4C93B0531}"/>
              </a:ext>
            </a:extLst>
          </p:cNvPr>
          <p:cNvSpPr/>
          <p:nvPr/>
        </p:nvSpPr>
        <p:spPr>
          <a:xfrm>
            <a:off x="2678917" y="5896347"/>
            <a:ext cx="8329283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Supplementary Figure 2 </a:t>
            </a:r>
          </a:p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A. 1 and 2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hr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plicing timepoints of WT VEGF-A splicing reporter and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DeltaBP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 with mutations in the branch point at -30 and -31 from exon 8a (CCCTAAC to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CCCTgg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</a:t>
            </a:r>
          </a:p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B. 2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hr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plicing reactions showing titrations (0, 1, 5, 10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u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of ESSOs 2-8.  Size markers on the left of panel A WT and panel B ESSO8 are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PhiX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HaeIII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DNA markers (1353, 1078, 872, 603, 310, 281, 271, 234,194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nt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.  Polyacrylamide gels were 5 or 6%</a:t>
            </a: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/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1D5B3C8E-CE77-D243-8148-7F8087D3044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196" r="1311" b="6309"/>
          <a:stretch/>
        </p:blipFill>
        <p:spPr>
          <a:xfrm>
            <a:off x="9531843" y="729926"/>
            <a:ext cx="1092748" cy="52573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Right Triangle 54">
            <a:extLst>
              <a:ext uri="{FF2B5EF4-FFF2-40B4-BE49-F238E27FC236}">
                <a16:creationId xmlns:a16="http://schemas.microsoft.com/office/drawing/2014/main" id="{631BE3B2-4625-9941-B8E4-D07D5F5FC946}"/>
              </a:ext>
            </a:extLst>
          </p:cNvPr>
          <p:cNvSpPr/>
          <p:nvPr/>
        </p:nvSpPr>
        <p:spPr>
          <a:xfrm flipH="1">
            <a:off x="9895992" y="484812"/>
            <a:ext cx="495958" cy="177800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4B63BB4-5FEC-0244-AF47-E4D4E8384A49}"/>
              </a:ext>
            </a:extLst>
          </p:cNvPr>
          <p:cNvSpPr txBox="1"/>
          <p:nvPr/>
        </p:nvSpPr>
        <p:spPr>
          <a:xfrm>
            <a:off x="9643450" y="80702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SSO9</a:t>
            </a:r>
          </a:p>
        </p:txBody>
      </p:sp>
    </p:spTree>
    <p:extLst>
      <p:ext uri="{BB962C8B-B14F-4D97-AF65-F5344CB8AC3E}">
        <p14:creationId xmlns:p14="http://schemas.microsoft.com/office/powerpoint/2010/main" val="2199746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53D2E07-ED0E-254E-8093-8E14DF190F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0952465"/>
              </p:ext>
            </p:extLst>
          </p:nvPr>
        </p:nvGraphicFramePr>
        <p:xfrm>
          <a:off x="5672380" y="1021397"/>
          <a:ext cx="6280712" cy="3498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78E294B-2CE5-B141-BACB-0517BC08F788}"/>
              </a:ext>
            </a:extLst>
          </p:cNvPr>
          <p:cNvSpPr txBox="1"/>
          <p:nvPr/>
        </p:nvSpPr>
        <p:spPr>
          <a:xfrm rot="16200000">
            <a:off x="3818474" y="2134363"/>
            <a:ext cx="3371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hospho-VEGFR2/VEGFR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88B1F8-92A4-BA4B-88AB-7E4CBB959613}"/>
              </a:ext>
            </a:extLst>
          </p:cNvPr>
          <p:cNvSpPr txBox="1"/>
          <p:nvPr/>
        </p:nvSpPr>
        <p:spPr>
          <a:xfrm>
            <a:off x="7242773" y="3429000"/>
            <a:ext cx="657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4A79D0A-26DA-A341-B077-48D2E7BB9574}"/>
              </a:ext>
            </a:extLst>
          </p:cNvPr>
          <p:cNvSpPr txBox="1"/>
          <p:nvPr/>
        </p:nvSpPr>
        <p:spPr>
          <a:xfrm>
            <a:off x="9180496" y="1636975"/>
            <a:ext cx="657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D16BAB6-BB9D-A941-B8FA-C3E57E71A949}"/>
              </a:ext>
            </a:extLst>
          </p:cNvPr>
          <p:cNvSpPr txBox="1"/>
          <p:nvPr/>
        </p:nvSpPr>
        <p:spPr>
          <a:xfrm>
            <a:off x="10125925" y="2865367"/>
            <a:ext cx="657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*</a:t>
            </a:r>
            <a:r>
              <a:rPr lang="en-US" sz="2400" baseline="30000" dirty="0"/>
              <a:t>#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B486D5-4374-E14C-B551-22F3937C94D5}"/>
              </a:ext>
            </a:extLst>
          </p:cNvPr>
          <p:cNvSpPr txBox="1"/>
          <p:nvPr/>
        </p:nvSpPr>
        <p:spPr>
          <a:xfrm>
            <a:off x="11151865" y="3881016"/>
            <a:ext cx="657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aseline="30000" dirty="0"/>
              <a:t>#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E512340-B194-7944-9D7F-1E5A37BC3F87}"/>
              </a:ext>
            </a:extLst>
          </p:cNvPr>
          <p:cNvSpPr txBox="1"/>
          <p:nvPr/>
        </p:nvSpPr>
        <p:spPr>
          <a:xfrm>
            <a:off x="783771" y="5460963"/>
            <a:ext cx="1091342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VEGFR2 phosphorylation is decreased by ESSO 1 and ESSO 3.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C3 cells were treated for 48 hours with DMSO, ESSO 1, or ESSO 3 in serum free (SF) media. PC3 conditioned media was then used to treat serum starved HUVECs for 5 mins to assess the phosphorylation of VEGFR2 (in addition to a SF, VEGF-A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6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 (1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, and VEGF-A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6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 (1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control). All three conditions resulted in a significant increase in phosphorylation of VEGFR2 (*p&lt;0.05 vs SF control); however, both ESSO 1 and ESSO 3 had a significant decrease in VEGFR2 phosphorylation relative to the DMSO control (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&lt;0.05 vs DMSO) (n=3, Kruskal-Wallis test).</a:t>
            </a:r>
            <a:endParaRPr lang="en-US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picture containing blur&#10;&#10;Description automatically generated">
            <a:extLst>
              <a:ext uri="{FF2B5EF4-FFF2-40B4-BE49-F238E27FC236}">
                <a16:creationId xmlns:a16="http://schemas.microsoft.com/office/drawing/2014/main" id="{AD5426FA-3394-384B-AF0B-EE7094481D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09716" y="2084908"/>
            <a:ext cx="2811836" cy="711200"/>
          </a:xfrm>
          <a:prstGeom prst="rect">
            <a:avLst/>
          </a:prstGeom>
        </p:spPr>
      </p:pic>
      <p:pic>
        <p:nvPicPr>
          <p:cNvPr id="14" name="Picture 13" descr="A close-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2B78BC13-83A6-2642-9306-49F7502C2B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09716" y="2971432"/>
            <a:ext cx="2811836" cy="7112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198FCFF-0AAA-B14B-BFB6-376AF03BD993}"/>
              </a:ext>
            </a:extLst>
          </p:cNvPr>
          <p:cNvSpPr txBox="1"/>
          <p:nvPr/>
        </p:nvSpPr>
        <p:spPr>
          <a:xfrm>
            <a:off x="3621552" y="2408073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hospho-VEGFR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87DE48-FBED-B046-BBFA-14E2575F6CD9}"/>
              </a:ext>
            </a:extLst>
          </p:cNvPr>
          <p:cNvSpPr txBox="1"/>
          <p:nvPr/>
        </p:nvSpPr>
        <p:spPr>
          <a:xfrm>
            <a:off x="3621551" y="3268951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EGFR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D25FCFD-18B8-D94E-805D-1D7518FED130}"/>
              </a:ext>
            </a:extLst>
          </p:cNvPr>
          <p:cNvSpPr txBox="1"/>
          <p:nvPr/>
        </p:nvSpPr>
        <p:spPr>
          <a:xfrm>
            <a:off x="135090" y="2376476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10 </a:t>
            </a:r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87F025A-F9BF-1C48-9207-C2B37A1E718E}"/>
              </a:ext>
            </a:extLst>
          </p:cNvPr>
          <p:cNvSpPr txBox="1"/>
          <p:nvPr/>
        </p:nvSpPr>
        <p:spPr>
          <a:xfrm>
            <a:off x="119246" y="3262852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10 </a:t>
            </a:r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1E50607-A4BC-DC43-9CD6-5AF5E0982828}"/>
              </a:ext>
            </a:extLst>
          </p:cNvPr>
          <p:cNvSpPr txBox="1"/>
          <p:nvPr/>
        </p:nvSpPr>
        <p:spPr>
          <a:xfrm rot="16200000">
            <a:off x="257745" y="1040333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F contro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B1B4A92-783A-0148-90A9-18434D9BE660}"/>
              </a:ext>
            </a:extLst>
          </p:cNvPr>
          <p:cNvSpPr txBox="1"/>
          <p:nvPr/>
        </p:nvSpPr>
        <p:spPr>
          <a:xfrm rot="16200000">
            <a:off x="636420" y="1040332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EGF-A</a:t>
            </a:r>
            <a:r>
              <a:rPr lang="en-US" sz="1200" baseline="-25000" dirty="0"/>
              <a:t>165</a:t>
            </a:r>
            <a:r>
              <a:rPr lang="en-US" sz="1200" dirty="0"/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4B0EA81-D8AB-794A-8B8A-88016CBAA470}"/>
              </a:ext>
            </a:extLst>
          </p:cNvPr>
          <p:cNvSpPr txBox="1"/>
          <p:nvPr/>
        </p:nvSpPr>
        <p:spPr>
          <a:xfrm rot="16200000">
            <a:off x="1063111" y="1052014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EGF-A</a:t>
            </a:r>
            <a:r>
              <a:rPr lang="en-US" sz="1200" baseline="-25000" dirty="0"/>
              <a:t>165</a:t>
            </a:r>
            <a:r>
              <a:rPr lang="en-US" sz="1200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028C9C8-9910-8A47-B3E6-CC29C0C64AAB}"/>
              </a:ext>
            </a:extLst>
          </p:cNvPr>
          <p:cNvSpPr txBox="1"/>
          <p:nvPr/>
        </p:nvSpPr>
        <p:spPr>
          <a:xfrm rot="16200000">
            <a:off x="1470496" y="1052013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8BF0BB1-54AC-804C-AA17-423C68F52AB6}"/>
              </a:ext>
            </a:extLst>
          </p:cNvPr>
          <p:cNvSpPr txBox="1"/>
          <p:nvPr/>
        </p:nvSpPr>
        <p:spPr>
          <a:xfrm rot="16200000">
            <a:off x="1956673" y="1052012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SSO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BD9F131-B69C-334A-9E8B-C913970F8FAE}"/>
              </a:ext>
            </a:extLst>
          </p:cNvPr>
          <p:cNvSpPr txBox="1"/>
          <p:nvPr/>
        </p:nvSpPr>
        <p:spPr>
          <a:xfrm rot="16200000">
            <a:off x="2442046" y="1049760"/>
            <a:ext cx="1797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SSO 3</a:t>
            </a:r>
          </a:p>
        </p:txBody>
      </p:sp>
    </p:spTree>
    <p:extLst>
      <p:ext uri="{BB962C8B-B14F-4D97-AF65-F5344CB8AC3E}">
        <p14:creationId xmlns:p14="http://schemas.microsoft.com/office/powerpoint/2010/main" val="2147531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9E003FA9-652B-D84D-96A5-59A637F59E53}"/>
              </a:ext>
            </a:extLst>
          </p:cNvPr>
          <p:cNvSpPr/>
          <p:nvPr/>
        </p:nvSpPr>
        <p:spPr>
          <a:xfrm>
            <a:off x="1575582" y="3929647"/>
            <a:ext cx="960035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ry Figure 4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ESSO1 inhibits angiogenesis in vivo.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ESSO1-treated PC3 cells (48 hours) were mixed with Matrigel. The Matrigel and control cells were injected subcutaneously into nude mice. Four days post-injection, the plugs were removed. </a:t>
            </a: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Photographs were taken of each plug and colour intensity quantified using ImageJ software. There was a clear reduction in ESSO1 plug intensity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picture containing food, white&#10;&#10;Description automatically generated">
            <a:extLst>
              <a:ext uri="{FF2B5EF4-FFF2-40B4-BE49-F238E27FC236}">
                <a16:creationId xmlns:a16="http://schemas.microsoft.com/office/drawing/2014/main" id="{93583719-6DDC-CA4E-80E6-40DA3F02E8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9579" y="1263837"/>
            <a:ext cx="4794445" cy="1425893"/>
          </a:xfrm>
          <a:prstGeom prst="rect">
            <a:avLst/>
          </a:prstGeom>
        </p:spPr>
      </p:pic>
      <p:pic>
        <p:nvPicPr>
          <p:cNvPr id="18" name="Picture 17" descr="Chart, bar chart, box and whisker chart&#10;&#10;Description automatically generated">
            <a:extLst>
              <a:ext uri="{FF2B5EF4-FFF2-40B4-BE49-F238E27FC236}">
                <a16:creationId xmlns:a16="http://schemas.microsoft.com/office/drawing/2014/main" id="{62BD87C4-DFEB-D240-820C-7EB6702E44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06199" y="770283"/>
            <a:ext cx="3187700" cy="241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01300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9CD430-56C3-1844-86C0-66BA040E69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8474" y="3352244"/>
            <a:ext cx="3374967" cy="25497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18CFEF2-5966-0D47-84B1-F4066C961541}"/>
              </a:ext>
            </a:extLst>
          </p:cNvPr>
          <p:cNvSpPr txBox="1"/>
          <p:nvPr/>
        </p:nvSpPr>
        <p:spPr>
          <a:xfrm>
            <a:off x="814308" y="6317656"/>
            <a:ext cx="108665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Supplementary Figure 5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. Structure and details of compounds ESSO 01, 02, 03, 07, 08, 09 (LOPAC library accompanying information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4B189D9-606B-A14C-A23C-3F9C16F610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308" y="373511"/>
            <a:ext cx="3389133" cy="256309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6EDFCCF-BB78-8440-B3AF-7C36EB5FCFA7}"/>
              </a:ext>
            </a:extLst>
          </p:cNvPr>
          <p:cNvSpPr txBox="1"/>
          <p:nvPr/>
        </p:nvSpPr>
        <p:spPr>
          <a:xfrm>
            <a:off x="2050470" y="83125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SSO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1060487-B51D-EA42-A2B3-8099490EC7B9}"/>
              </a:ext>
            </a:extLst>
          </p:cNvPr>
          <p:cNvSpPr txBox="1"/>
          <p:nvPr/>
        </p:nvSpPr>
        <p:spPr>
          <a:xfrm>
            <a:off x="1953485" y="3066042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SSO07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5842BC2-BD23-D94A-8F10-2DFE5327B2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0106" y="373511"/>
            <a:ext cx="3374967" cy="252545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7A287C8-C224-CD4A-8944-D0A8B93D0B65}"/>
              </a:ext>
            </a:extLst>
          </p:cNvPr>
          <p:cNvSpPr txBox="1"/>
          <p:nvPr/>
        </p:nvSpPr>
        <p:spPr>
          <a:xfrm>
            <a:off x="5842878" y="18040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SSO02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BBDF879-A389-C848-875B-816F859CC1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96878" y="373510"/>
            <a:ext cx="3371664" cy="249700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63478-879D-B746-AEA2-D7D3F6596D31}"/>
              </a:ext>
            </a:extLst>
          </p:cNvPr>
          <p:cNvSpPr txBox="1"/>
          <p:nvPr/>
        </p:nvSpPr>
        <p:spPr>
          <a:xfrm>
            <a:off x="9574510" y="83125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SSO03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ABA9D8B4-7C11-4D49-A911-B9F9816EB9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60107" y="3374167"/>
            <a:ext cx="3359438" cy="252784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CCEBA88-81A3-9C4D-8461-8C9B054F2874}"/>
              </a:ext>
            </a:extLst>
          </p:cNvPr>
          <p:cNvSpPr txBox="1"/>
          <p:nvPr/>
        </p:nvSpPr>
        <p:spPr>
          <a:xfrm>
            <a:off x="5793550" y="2982912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SSO08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46CB1A2A-D957-B145-9687-CD2C34F2D5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22958" y="3366099"/>
            <a:ext cx="3359439" cy="251957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52E8D52-F97F-254D-8857-5F28268D60F7}"/>
              </a:ext>
            </a:extLst>
          </p:cNvPr>
          <p:cNvSpPr txBox="1"/>
          <p:nvPr/>
        </p:nvSpPr>
        <p:spPr>
          <a:xfrm>
            <a:off x="9509654" y="3014625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SSO09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9642E68-9897-A247-8B8A-80A997694542}"/>
              </a:ext>
            </a:extLst>
          </p:cNvPr>
          <p:cNvSpPr txBox="1"/>
          <p:nvPr/>
        </p:nvSpPr>
        <p:spPr>
          <a:xfrm>
            <a:off x="11887200" y="141316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068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9</TotalTime>
  <Words>571</Words>
  <Application>Microsoft Macintosh PowerPoint</Application>
  <PresentationFormat>Widescreen</PresentationFormat>
  <Paragraphs>53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bastian Oltean</dc:creator>
  <cp:lastModifiedBy>Oltean, Seb</cp:lastModifiedBy>
  <cp:revision>43</cp:revision>
  <dcterms:created xsi:type="dcterms:W3CDTF">2017-06-26T11:40:08Z</dcterms:created>
  <dcterms:modified xsi:type="dcterms:W3CDTF">2021-04-08T22:20:46Z</dcterms:modified>
</cp:coreProperties>
</file>